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14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ad\group\PPT-T-Neuroplasticity\Paradigmen%20der%20tDCS\Datenzusammenf&#252;hrung%20Frase%2012%202020\rTMS\aBBILDUNGEN%20neu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oleObject" Target="file:///\\ad\group\PPT-T-Neuroplasticity\Paradigmen%20der%20tDCS\Datenzusammenf&#252;hrung%20Frase%2012%202020\rTMS\aBBILDUNGEN%20neu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ad\group\PPT-T-Neuroplasticity\Paradigmen%20der%20tDCS\Datenzusammenf&#252;hrung%20Frase%2012%202020\rTMS\aBBILDUNGEN%20neu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v>Experiment B1</c:v>
          </c:tx>
          <c:spPr>
            <a:ln w="25400" cap="rnd">
              <a:solidFill>
                <a:srgbClr val="BE0028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iment B'!$H$75:$H$7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2667857277377259</c:v>
                  </c:pt>
                  <c:pt idx="2">
                    <c:v>0.17498243242435182</c:v>
                  </c:pt>
                  <c:pt idx="3">
                    <c:v>0.3211337348475598</c:v>
                  </c:pt>
                </c:numCache>
              </c:numRef>
            </c:plus>
            <c:minus>
              <c:numRef>
                <c:f>'Experiment B'!$H$75:$H$7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2667857277377259</c:v>
                  </c:pt>
                  <c:pt idx="2">
                    <c:v>0.17498243242435182</c:v>
                  </c:pt>
                  <c:pt idx="3">
                    <c:v>0.321133734847559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iment B'!$B$74:$B$77</c:f>
              <c:numCache>
                <c:formatCode>General</c:formatCode>
                <c:ptCount val="4"/>
                <c:pt idx="0">
                  <c:v>0.5</c:v>
                </c:pt>
                <c:pt idx="1">
                  <c:v>18.5</c:v>
                </c:pt>
                <c:pt idx="2">
                  <c:v>43.5</c:v>
                </c:pt>
                <c:pt idx="3">
                  <c:v>73.5</c:v>
                </c:pt>
              </c:numCache>
            </c:numRef>
          </c:xVal>
          <c:yVal>
            <c:numRef>
              <c:f>'Experiment B'!$C$74:$C$77</c:f>
              <c:numCache>
                <c:formatCode>General</c:formatCode>
                <c:ptCount val="4"/>
                <c:pt idx="0">
                  <c:v>1</c:v>
                </c:pt>
                <c:pt idx="1">
                  <c:v>1.1732</c:v>
                </c:pt>
                <c:pt idx="2">
                  <c:v>1.0092000000000001</c:v>
                </c:pt>
                <c:pt idx="3">
                  <c:v>1.17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745-49FF-9856-652E6E827DEF}"/>
            </c:ext>
          </c:extLst>
        </c:ser>
        <c:ser>
          <c:idx val="1"/>
          <c:order val="1"/>
          <c:tx>
            <c:v>Experiment B2</c:v>
          </c:tx>
          <c:spPr>
            <a:ln w="25400" cap="rnd">
              <a:solidFill>
                <a:srgbClr val="004B9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iment B'!$H$79:$H$8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4910658817347046E-2</c:v>
                  </c:pt>
                  <c:pt idx="2">
                    <c:v>0.11485962370277406</c:v>
                  </c:pt>
                  <c:pt idx="3">
                    <c:v>0.18147208242592025</c:v>
                  </c:pt>
                </c:numCache>
              </c:numRef>
            </c:plus>
            <c:minus>
              <c:numRef>
                <c:f>'Experiment B'!$H$79:$H$8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4910658817347046E-2</c:v>
                  </c:pt>
                  <c:pt idx="2">
                    <c:v>0.11485962370277406</c:v>
                  </c:pt>
                  <c:pt idx="3">
                    <c:v>0.1814720824259202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iment B'!$B$78:$B$81</c:f>
              <c:numCache>
                <c:formatCode>General</c:formatCode>
                <c:ptCount val="4"/>
                <c:pt idx="0">
                  <c:v>1</c:v>
                </c:pt>
                <c:pt idx="1">
                  <c:v>19</c:v>
                </c:pt>
                <c:pt idx="2">
                  <c:v>44</c:v>
                </c:pt>
                <c:pt idx="3">
                  <c:v>74</c:v>
                </c:pt>
              </c:numCache>
            </c:numRef>
          </c:xVal>
          <c:yVal>
            <c:numRef>
              <c:f>'Experiment B'!$D$78:$D$81</c:f>
              <c:numCache>
                <c:formatCode>General</c:formatCode>
                <c:ptCount val="4"/>
                <c:pt idx="0">
                  <c:v>1</c:v>
                </c:pt>
                <c:pt idx="1">
                  <c:v>0.75749999999999995</c:v>
                </c:pt>
                <c:pt idx="2">
                  <c:v>0.60619999999999996</c:v>
                </c:pt>
                <c:pt idx="3">
                  <c:v>0.79259999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745-49FF-9856-652E6E827DEF}"/>
            </c:ext>
          </c:extLst>
        </c:ser>
        <c:ser>
          <c:idx val="2"/>
          <c:order val="2"/>
          <c:tx>
            <c:v>Experiment B3</c:v>
          </c:tx>
          <c:spPr>
            <a:ln w="2540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iment B'!$H$83:$H$8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6402524235181434</c:v>
                  </c:pt>
                  <c:pt idx="2">
                    <c:v>0.14141540757640236</c:v>
                  </c:pt>
                  <c:pt idx="3">
                    <c:v>0.31688919381566616</c:v>
                  </c:pt>
                </c:numCache>
              </c:numRef>
            </c:plus>
            <c:minus>
              <c:numRef>
                <c:f>'Experiment B'!$H$83:$H$8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6402524235181434</c:v>
                  </c:pt>
                  <c:pt idx="2">
                    <c:v>0.14141540757640236</c:v>
                  </c:pt>
                  <c:pt idx="3">
                    <c:v>0.3168891938156661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iment B'!$B$82:$B$85</c:f>
              <c:numCache>
                <c:formatCode>General</c:formatCode>
                <c:ptCount val="4"/>
                <c:pt idx="0">
                  <c:v>0</c:v>
                </c:pt>
                <c:pt idx="1">
                  <c:v>18</c:v>
                </c:pt>
                <c:pt idx="2">
                  <c:v>43</c:v>
                </c:pt>
                <c:pt idx="3">
                  <c:v>73</c:v>
                </c:pt>
              </c:numCache>
            </c:numRef>
          </c:xVal>
          <c:yVal>
            <c:numRef>
              <c:f>'Experiment B'!$E$82:$E$85</c:f>
              <c:numCache>
                <c:formatCode>General</c:formatCode>
                <c:ptCount val="4"/>
                <c:pt idx="0">
                  <c:v>1</c:v>
                </c:pt>
                <c:pt idx="1">
                  <c:v>1.1289</c:v>
                </c:pt>
                <c:pt idx="2">
                  <c:v>1.5157</c:v>
                </c:pt>
                <c:pt idx="3">
                  <c:v>1.8331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4745-49FF-9856-652E6E827D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4494536"/>
        <c:axId val="594494864"/>
      </c:scatterChart>
      <c:valAx>
        <c:axId val="594494536"/>
        <c:scaling>
          <c:orientation val="minMax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94494864"/>
        <c:crossesAt val="1"/>
        <c:crossBetween val="midCat"/>
      </c:valAx>
      <c:valAx>
        <c:axId val="594494864"/>
        <c:scaling>
          <c:orientation val="minMax"/>
          <c:max val="2.2000000000000002"/>
          <c:min val="0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1400"/>
                  <a:t>Normalized MEP amplitude, µV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94494536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solidFill>
                <a:srgbClr val="C51C40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iment C'!$H$29:$H$3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7507514448328474</c:v>
                  </c:pt>
                  <c:pt idx="2">
                    <c:v>0.19845305367391047</c:v>
                  </c:pt>
                  <c:pt idx="3">
                    <c:v>0.11611400453864296</c:v>
                  </c:pt>
                </c:numCache>
              </c:numRef>
            </c:plus>
            <c:minus>
              <c:numRef>
                <c:f>'Experiment C'!$H$29:$H$3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7507514448328474</c:v>
                  </c:pt>
                  <c:pt idx="2">
                    <c:v>0.19845305367391047</c:v>
                  </c:pt>
                  <c:pt idx="3">
                    <c:v>0.1161140045386429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iment C'!$B$29:$B$32</c:f>
              <c:numCache>
                <c:formatCode>General</c:formatCode>
                <c:ptCount val="4"/>
                <c:pt idx="0">
                  <c:v>0.5</c:v>
                </c:pt>
                <c:pt idx="1">
                  <c:v>18.5</c:v>
                </c:pt>
                <c:pt idx="2">
                  <c:v>43.5</c:v>
                </c:pt>
                <c:pt idx="3">
                  <c:v>73.5</c:v>
                </c:pt>
              </c:numCache>
            </c:numRef>
          </c:xVal>
          <c:yVal>
            <c:numRef>
              <c:f>'Experiment C'!$C$29:$C$32</c:f>
              <c:numCache>
                <c:formatCode>General</c:formatCode>
                <c:ptCount val="4"/>
                <c:pt idx="0">
                  <c:v>1</c:v>
                </c:pt>
                <c:pt idx="1">
                  <c:v>1.1777</c:v>
                </c:pt>
                <c:pt idx="2">
                  <c:v>1.2548999999999999</c:v>
                </c:pt>
                <c:pt idx="3">
                  <c:v>1.0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B20-4BFF-BF6E-B335FCBA2617}"/>
            </c:ext>
          </c:extLst>
        </c:ser>
        <c:ser>
          <c:idx val="1"/>
          <c:order val="1"/>
          <c:spPr>
            <a:ln w="25400" cap="rnd">
              <a:solidFill>
                <a:srgbClr val="004B9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iment C'!$H$33:$H$3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5299669424533327</c:v>
                  </c:pt>
                  <c:pt idx="2">
                    <c:v>0.165731687374503</c:v>
                  </c:pt>
                  <c:pt idx="3">
                    <c:v>0.19049456685165586</c:v>
                  </c:pt>
                </c:numCache>
              </c:numRef>
            </c:plus>
            <c:minus>
              <c:numRef>
                <c:f>'Experiment C'!$H$33:$H$3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5299669424533327</c:v>
                  </c:pt>
                  <c:pt idx="2">
                    <c:v>0.165731687374503</c:v>
                  </c:pt>
                  <c:pt idx="3">
                    <c:v>0.19049456685165586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iment C'!$B$33:$B$36</c:f>
              <c:numCache>
                <c:formatCode>General</c:formatCode>
                <c:ptCount val="4"/>
                <c:pt idx="0">
                  <c:v>1</c:v>
                </c:pt>
                <c:pt idx="1">
                  <c:v>19</c:v>
                </c:pt>
                <c:pt idx="2">
                  <c:v>44</c:v>
                </c:pt>
                <c:pt idx="3">
                  <c:v>74</c:v>
                </c:pt>
              </c:numCache>
            </c:numRef>
          </c:xVal>
          <c:yVal>
            <c:numRef>
              <c:f>'Experiment C'!$D$33:$D$36</c:f>
              <c:numCache>
                <c:formatCode>General</c:formatCode>
                <c:ptCount val="4"/>
                <c:pt idx="0">
                  <c:v>1</c:v>
                </c:pt>
                <c:pt idx="1">
                  <c:v>1.2142999999999999</c:v>
                </c:pt>
                <c:pt idx="2">
                  <c:v>1.2936000000000001</c:v>
                </c:pt>
                <c:pt idx="3">
                  <c:v>1.223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B20-4BFF-BF6E-B335FCBA2617}"/>
            </c:ext>
          </c:extLst>
        </c:ser>
        <c:ser>
          <c:idx val="2"/>
          <c:order val="2"/>
          <c:spPr>
            <a:ln w="25400" cap="rnd">
              <a:solidFill>
                <a:srgbClr val="D5D5D5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iment C'!$H$37:$H$4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3048181336337785E-2</c:v>
                  </c:pt>
                  <c:pt idx="2">
                    <c:v>0.13135922674102493</c:v>
                  </c:pt>
                  <c:pt idx="3">
                    <c:v>0.16511296894096475</c:v>
                  </c:pt>
                </c:numCache>
              </c:numRef>
            </c:plus>
            <c:minus>
              <c:numRef>
                <c:f>'Experiment C'!$H$37:$H$40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9.3048181336337785E-2</c:v>
                  </c:pt>
                  <c:pt idx="2">
                    <c:v>0.13135922674102493</c:v>
                  </c:pt>
                  <c:pt idx="3">
                    <c:v>0.16511296894096475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iment C'!$B$37:$B$40</c:f>
              <c:numCache>
                <c:formatCode>General</c:formatCode>
                <c:ptCount val="4"/>
                <c:pt idx="0">
                  <c:v>0</c:v>
                </c:pt>
                <c:pt idx="1">
                  <c:v>18</c:v>
                </c:pt>
                <c:pt idx="2">
                  <c:v>43</c:v>
                </c:pt>
                <c:pt idx="3">
                  <c:v>73</c:v>
                </c:pt>
              </c:numCache>
            </c:numRef>
          </c:xVal>
          <c:yVal>
            <c:numRef>
              <c:f>'Experiment C'!$E$37:$E$40</c:f>
              <c:numCache>
                <c:formatCode>General</c:formatCode>
                <c:ptCount val="4"/>
                <c:pt idx="0">
                  <c:v>1</c:v>
                </c:pt>
                <c:pt idx="1">
                  <c:v>1.0210999999999999</c:v>
                </c:pt>
                <c:pt idx="2">
                  <c:v>1.4611000000000001</c:v>
                </c:pt>
                <c:pt idx="3">
                  <c:v>1.3796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B20-4BFF-BF6E-B335FCBA26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4494536"/>
        <c:axId val="594494864"/>
      </c:scatterChart>
      <c:valAx>
        <c:axId val="594494536"/>
        <c:scaling>
          <c:orientation val="minMax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94494864"/>
        <c:crossesAt val="1"/>
        <c:crossBetween val="midCat"/>
      </c:valAx>
      <c:valAx>
        <c:axId val="594494864"/>
        <c:scaling>
          <c:orientation val="minMax"/>
          <c:max val="2.2000000000000002"/>
          <c:min val="0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1400" dirty="0" err="1"/>
                  <a:t>Normalized</a:t>
                </a:r>
                <a:r>
                  <a:rPr lang="de-DE" sz="1400" dirty="0"/>
                  <a:t> MEP </a:t>
                </a:r>
                <a:r>
                  <a:rPr lang="de-DE" sz="1400" dirty="0" err="1"/>
                  <a:t>amplitude</a:t>
                </a:r>
                <a:r>
                  <a:rPr lang="de-DE" sz="1400" dirty="0"/>
                  <a:t>, µV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94494536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2"/>
          <c:order val="0"/>
          <c:tx>
            <c:v>S</c:v>
          </c:tx>
          <c:spPr>
            <a:ln w="25400" cap="rnd">
              <a:solidFill>
                <a:srgbClr val="C8C8C8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ment A'!$I$13:$I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812805661704623</c:v>
                  </c:pt>
                  <c:pt idx="2">
                    <c:v>0.15149572007155845</c:v>
                  </c:pt>
                  <c:pt idx="3">
                    <c:v>0.16981187843358561</c:v>
                  </c:pt>
                </c:numCache>
              </c:numRef>
            </c:plus>
            <c:minus>
              <c:numRef>
                <c:f>'Experment A'!$I$13:$I$1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812805661704623</c:v>
                  </c:pt>
                  <c:pt idx="2">
                    <c:v>0.15149572007155845</c:v>
                  </c:pt>
                  <c:pt idx="3">
                    <c:v>0.1698118784335856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ment A'!$B$13:$B$16</c:f>
              <c:numCache>
                <c:formatCode>General</c:formatCode>
                <c:ptCount val="4"/>
                <c:pt idx="0">
                  <c:v>0</c:v>
                </c:pt>
                <c:pt idx="1">
                  <c:v>18</c:v>
                </c:pt>
                <c:pt idx="2">
                  <c:v>43</c:v>
                </c:pt>
                <c:pt idx="3">
                  <c:v>73</c:v>
                </c:pt>
              </c:numCache>
            </c:numRef>
          </c:xVal>
          <c:yVal>
            <c:numRef>
              <c:f>'Experment A'!$E$13:$E$16</c:f>
              <c:numCache>
                <c:formatCode>General</c:formatCode>
                <c:ptCount val="4"/>
                <c:pt idx="0">
                  <c:v>1</c:v>
                </c:pt>
                <c:pt idx="1">
                  <c:v>1.2895000000000001</c:v>
                </c:pt>
                <c:pt idx="2">
                  <c:v>1.5524</c:v>
                </c:pt>
                <c:pt idx="3">
                  <c:v>1.0287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737-424A-827E-FE4C1E0D40C8}"/>
            </c:ext>
          </c:extLst>
        </c:ser>
        <c:ser>
          <c:idx val="1"/>
          <c:order val="1"/>
          <c:tx>
            <c:v>K</c:v>
          </c:tx>
          <c:spPr>
            <a:ln w="25400" cap="rnd">
              <a:solidFill>
                <a:srgbClr val="004B96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ment A'!$I$9:$I$1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02663955784543</c:v>
                  </c:pt>
                  <c:pt idx="2">
                    <c:v>0.16875735755388985</c:v>
                  </c:pt>
                  <c:pt idx="3">
                    <c:v>0.24240373511973778</c:v>
                  </c:pt>
                </c:numCache>
              </c:numRef>
            </c:plus>
            <c:minus>
              <c:numRef>
                <c:f>'Experment A'!$I$9:$I$12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02663955784543</c:v>
                  </c:pt>
                  <c:pt idx="2">
                    <c:v>0.16875735755388985</c:v>
                  </c:pt>
                  <c:pt idx="3">
                    <c:v>0.2424037351197377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ment A'!$B$9:$B$12</c:f>
              <c:numCache>
                <c:formatCode>General</c:formatCode>
                <c:ptCount val="4"/>
                <c:pt idx="0">
                  <c:v>1</c:v>
                </c:pt>
                <c:pt idx="1">
                  <c:v>19</c:v>
                </c:pt>
                <c:pt idx="2">
                  <c:v>44</c:v>
                </c:pt>
                <c:pt idx="3">
                  <c:v>74</c:v>
                </c:pt>
              </c:numCache>
            </c:numRef>
          </c:xVal>
          <c:yVal>
            <c:numRef>
              <c:f>'Experment A'!$D$9:$D$12</c:f>
              <c:numCache>
                <c:formatCode>General</c:formatCode>
                <c:ptCount val="4"/>
                <c:pt idx="0">
                  <c:v>1</c:v>
                </c:pt>
                <c:pt idx="1">
                  <c:v>1.0421</c:v>
                </c:pt>
                <c:pt idx="2">
                  <c:v>0.97519999999999996</c:v>
                </c:pt>
                <c:pt idx="3">
                  <c:v>1.181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37-424A-827E-FE4C1E0D40C8}"/>
            </c:ext>
          </c:extLst>
        </c:ser>
        <c:ser>
          <c:idx val="0"/>
          <c:order val="2"/>
          <c:tx>
            <c:v>A</c:v>
          </c:tx>
          <c:spPr>
            <a:ln w="25400" cap="rnd">
              <a:solidFill>
                <a:srgbClr val="BE0028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erment A'!$I$5:$I$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6260951763247616E-2</c:v>
                  </c:pt>
                  <c:pt idx="2">
                    <c:v>0.2196578331340425</c:v>
                  </c:pt>
                  <c:pt idx="3">
                    <c:v>0.28870060341863801</c:v>
                  </c:pt>
                </c:numCache>
              </c:numRef>
            </c:plus>
            <c:minus>
              <c:numRef>
                <c:f>'Experment A'!$I$5:$I$8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6260951763247616E-2</c:v>
                  </c:pt>
                  <c:pt idx="2">
                    <c:v>0.2196578331340425</c:v>
                  </c:pt>
                  <c:pt idx="3">
                    <c:v>0.2887006034186380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'Experment A'!$B$5:$B$8</c:f>
              <c:numCache>
                <c:formatCode>General</c:formatCode>
                <c:ptCount val="4"/>
                <c:pt idx="0">
                  <c:v>0.5</c:v>
                </c:pt>
                <c:pt idx="1">
                  <c:v>18.5</c:v>
                </c:pt>
                <c:pt idx="2">
                  <c:v>43.5</c:v>
                </c:pt>
                <c:pt idx="3">
                  <c:v>73.5</c:v>
                </c:pt>
              </c:numCache>
            </c:numRef>
          </c:xVal>
          <c:yVal>
            <c:numRef>
              <c:f>'Experment A'!$C$5:$C$8</c:f>
              <c:numCache>
                <c:formatCode>General</c:formatCode>
                <c:ptCount val="4"/>
                <c:pt idx="0">
                  <c:v>1</c:v>
                </c:pt>
                <c:pt idx="1">
                  <c:v>1.0482</c:v>
                </c:pt>
                <c:pt idx="2">
                  <c:v>1.2509999999999999</c:v>
                </c:pt>
                <c:pt idx="3">
                  <c:v>1.6763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737-424A-827E-FE4C1E0D40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4494536"/>
        <c:axId val="594494864"/>
      </c:scatterChart>
      <c:valAx>
        <c:axId val="594494536"/>
        <c:scaling>
          <c:orientation val="minMax"/>
          <c:min val="0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94494864"/>
        <c:crossesAt val="1"/>
        <c:crossBetween val="midCat"/>
      </c:valAx>
      <c:valAx>
        <c:axId val="594494864"/>
        <c:scaling>
          <c:orientation val="minMax"/>
          <c:max val="2.2000000000000002"/>
          <c:min val="0.4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de-DE" sz="1400" dirty="0" err="1"/>
                  <a:t>Normalized</a:t>
                </a:r>
                <a:r>
                  <a:rPr lang="de-DE" sz="1400" dirty="0"/>
                  <a:t> MEP </a:t>
                </a:r>
                <a:r>
                  <a:rPr lang="de-DE" sz="1400" dirty="0" err="1"/>
                  <a:t>amplitude</a:t>
                </a:r>
                <a:r>
                  <a:rPr lang="de-DE" sz="1400" dirty="0"/>
                  <a:t>, µV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594494536"/>
        <c:crossesAt val="0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>
          <a:latin typeface="Arial" panose="020B0604020202020204" pitchFamily="34" charset="0"/>
          <a:cs typeface="Arial" panose="020B0604020202020204" pitchFamily="34" charset="0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98873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49596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2606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99037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67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6614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9087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119855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7222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3358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041507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8DDB82-4415-45F8-8E52-BE569A3772B0}" type="datetimeFigureOut">
              <a:rPr lang="de-DE" smtClean="0"/>
              <a:t>15.05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74D5E-7F22-4CBE-A440-74B438A774F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99524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Diagramm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82323394"/>
              </p:ext>
            </p:extLst>
          </p:nvPr>
        </p:nvGraphicFramePr>
        <p:xfrm>
          <a:off x="3898428" y="778783"/>
          <a:ext cx="396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0" name="Textfeld 29"/>
          <p:cNvSpPr txBox="1"/>
          <p:nvPr/>
        </p:nvSpPr>
        <p:spPr>
          <a:xfrm>
            <a:off x="6173868" y="3665970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1" name="Textfeld 30"/>
          <p:cNvSpPr txBox="1"/>
          <p:nvPr/>
        </p:nvSpPr>
        <p:spPr>
          <a:xfrm>
            <a:off x="6121310" y="1592768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7228034" y="778783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3" name="Rechteck 32"/>
          <p:cNvSpPr/>
          <p:nvPr/>
        </p:nvSpPr>
        <p:spPr>
          <a:xfrm>
            <a:off x="5423538" y="1228227"/>
            <a:ext cx="172483" cy="1385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4" name="Textfeld 33"/>
          <p:cNvSpPr txBox="1"/>
          <p:nvPr/>
        </p:nvSpPr>
        <p:spPr>
          <a:xfrm>
            <a:off x="5245090" y="3381757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aphicFrame>
        <p:nvGraphicFramePr>
          <p:cNvPr id="35" name="Diagramm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98280357"/>
              </p:ext>
            </p:extLst>
          </p:nvPr>
        </p:nvGraphicFramePr>
        <p:xfrm>
          <a:off x="7982370" y="778783"/>
          <a:ext cx="396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7" name="Textfeld 36"/>
          <p:cNvSpPr txBox="1"/>
          <p:nvPr/>
        </p:nvSpPr>
        <p:spPr>
          <a:xfrm>
            <a:off x="10117634" y="1687802"/>
            <a:ext cx="344966" cy="369332"/>
          </a:xfrm>
          <a:prstGeom prst="rect">
            <a:avLst/>
          </a:prstGeom>
          <a:noFill/>
        </p:spPr>
        <p:txBody>
          <a:bodyPr wrap="square" lIns="187200" rtlCol="0">
            <a:spAutoFit/>
          </a:bodyPr>
          <a:lstStyle/>
          <a:p>
            <a:r>
              <a:rPr lang="de-DE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de-DE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8" name="Diagramm 3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1142775"/>
              </p:ext>
            </p:extLst>
          </p:nvPr>
        </p:nvGraphicFramePr>
        <p:xfrm>
          <a:off x="-7051" y="778783"/>
          <a:ext cx="3960000" cy="32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9" name="Rechteck 38"/>
          <p:cNvSpPr/>
          <p:nvPr/>
        </p:nvSpPr>
        <p:spPr>
          <a:xfrm>
            <a:off x="906034" y="1137352"/>
            <a:ext cx="377271" cy="252286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solidFill>
                  <a:srgbClr val="5959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  <a:endParaRPr lang="de-DE" sz="2000" dirty="0">
              <a:solidFill>
                <a:srgbClr val="59595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2207235" y="1510650"/>
            <a:ext cx="344966" cy="369332"/>
          </a:xfrm>
          <a:prstGeom prst="rect">
            <a:avLst/>
          </a:prstGeom>
          <a:noFill/>
        </p:spPr>
        <p:txBody>
          <a:bodyPr wrap="square" lIns="100800" rtlCol="0">
            <a:spAutoFit/>
          </a:bodyPr>
          <a:lstStyle/>
          <a:p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1" name="Rechteck 40"/>
          <p:cNvSpPr/>
          <p:nvPr/>
        </p:nvSpPr>
        <p:spPr>
          <a:xfrm>
            <a:off x="4802903" y="1228227"/>
            <a:ext cx="377271" cy="252286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solidFill>
                  <a:srgbClr val="5959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  <a:endParaRPr lang="de-DE" sz="2000" dirty="0">
              <a:solidFill>
                <a:srgbClr val="59595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hteck 41"/>
          <p:cNvSpPr/>
          <p:nvPr/>
        </p:nvSpPr>
        <p:spPr>
          <a:xfrm>
            <a:off x="8887778" y="1228227"/>
            <a:ext cx="377271" cy="2522862"/>
          </a:xfrm>
          <a:prstGeom prst="rect">
            <a:avLst/>
          </a:prstGeom>
          <a:solidFill>
            <a:schemeClr val="bg1">
              <a:lumMod val="75000"/>
              <a:alpha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vert270" rtlCol="0" anchor="ctr"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de-DE" sz="1400" dirty="0">
                <a:solidFill>
                  <a:srgbClr val="5959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S</a:t>
            </a:r>
            <a:endParaRPr lang="de-DE" sz="2000" dirty="0">
              <a:solidFill>
                <a:srgbClr val="59595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119361" y="52289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solidFill>
                  <a:srgbClr val="5959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7700400" y="52289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>
                <a:solidFill>
                  <a:srgbClr val="5959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3742452" y="522894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dirty="0" smtClean="0">
                <a:solidFill>
                  <a:srgbClr val="59595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de-DE" sz="2000" dirty="0">
              <a:solidFill>
                <a:srgbClr val="59595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hteck 45"/>
          <p:cNvSpPr/>
          <p:nvPr/>
        </p:nvSpPr>
        <p:spPr>
          <a:xfrm>
            <a:off x="1897983" y="3966703"/>
            <a:ext cx="9634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ime, min</a:t>
            </a:r>
          </a:p>
        </p:txBody>
      </p:sp>
      <p:sp>
        <p:nvSpPr>
          <p:cNvPr id="47" name="Rechteck 46"/>
          <p:cNvSpPr/>
          <p:nvPr/>
        </p:nvSpPr>
        <p:spPr>
          <a:xfrm>
            <a:off x="5852057" y="3963670"/>
            <a:ext cx="9634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ime, min</a:t>
            </a:r>
          </a:p>
        </p:txBody>
      </p:sp>
      <p:sp>
        <p:nvSpPr>
          <p:cNvPr id="48" name="Rechteck 47"/>
          <p:cNvSpPr/>
          <p:nvPr/>
        </p:nvSpPr>
        <p:spPr>
          <a:xfrm>
            <a:off x="9809017" y="3963669"/>
            <a:ext cx="96346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Time, min</a:t>
            </a:r>
          </a:p>
        </p:txBody>
      </p:sp>
      <p:sp>
        <p:nvSpPr>
          <p:cNvPr id="21" name="Rechteck 20"/>
          <p:cNvSpPr/>
          <p:nvPr/>
        </p:nvSpPr>
        <p:spPr>
          <a:xfrm>
            <a:off x="2071451" y="569060"/>
            <a:ext cx="6174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 = 7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5852057" y="573551"/>
            <a:ext cx="6174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 = 7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hteck 22"/>
          <p:cNvSpPr/>
          <p:nvPr/>
        </p:nvSpPr>
        <p:spPr>
          <a:xfrm>
            <a:off x="9981378" y="569059"/>
            <a:ext cx="61747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>
              <a:defRPr sz="1000" b="0" i="0" u="none" strike="noStrike" kern="1200" baseline="0">
                <a:solidFill>
                  <a:sysClr val="windowText" lastClr="000000">
                    <a:lumMod val="65000"/>
                    <a:lumOff val="35000"/>
                  </a:sysClr>
                </a:solidFill>
                <a:latin typeface="+mn-lt"/>
                <a:ea typeface="+mn-ea"/>
                <a:cs typeface="+mn-cs"/>
              </a:defRPr>
            </a:pP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 = 8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7055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Breitbild</PresentationFormat>
  <Paragraphs>2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Lukas Frase</dc:creator>
  <cp:lastModifiedBy>Dr. Lukas Frase</cp:lastModifiedBy>
  <cp:revision>6</cp:revision>
  <dcterms:created xsi:type="dcterms:W3CDTF">2022-11-04T14:31:07Z</dcterms:created>
  <dcterms:modified xsi:type="dcterms:W3CDTF">2024-05-15T12:53:00Z</dcterms:modified>
</cp:coreProperties>
</file>